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-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A4AA6C-89C8-03E1-16E8-D328B6DB65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0230DD-A544-3EAF-FC9E-E8EE99CF54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D1F1B0-8EAA-5428-341B-A6D8D4905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6FE107-ACD1-7165-D393-ABB99168A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14C1D0-DEC4-F6C9-431C-E75BA20C7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3375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CD8A84-9538-A865-1774-5696549D20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584DDB-F5D3-1F10-8867-B5D82EB1CB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A7BA50-EFFD-726B-0C14-56DD030F1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6CF491-F44B-2A42-73D8-F436AD76E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C4217D-7175-1FB7-54D9-00E38220D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9255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E4FD2F-2B1F-7218-97DB-3A97309E22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1D754C-CB0D-03AB-EC31-95B80F7C7F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DF906-C969-2BED-045C-9697ECC49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97C95A-95B4-422B-4E3C-293605830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25E8D7-7AD6-C780-C19A-438C12168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70392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6AB956-75E0-1DE2-82A6-FB99D03F7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27C8CB-BB4D-C958-AE80-DD01F72889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457D07-634C-2363-0274-AEF1D7BDC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39AEDA-56D4-F510-47E6-A6F8D73DB9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33196-76DC-B57E-CB95-00D4E5D87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40157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6CF43B-F8BA-999B-901B-9C7994987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D55F22-890D-CACD-B16D-CE3D7F46DE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5B0ADA-738F-C546-0BD8-6DEC40F56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5A0333-2679-8CCC-BBA3-6B6D41821D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5D2741-009A-17D0-9D67-09B99FA8A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35516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AC77C0-7C0F-F31F-9EE1-CE15284D2D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61D73C-6DD9-E3F1-8316-5AEA507129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B90322-A9D6-F14E-C4B2-B3DB3338C8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DDAD47-F0B5-163E-A9F7-809FA02FB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FECED8-8A24-9EBB-9855-AEFCB2603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747B48-2EF7-2AD8-F877-090C570BC2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45343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B4C5A3-3995-5A1F-1412-88596990EA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A5E849-438A-8FC1-11B7-56EBBBA90D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F66F6C-4B94-4096-0E39-C0C7C74930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D9FC03B-A80C-0F14-5FE4-037ECA2589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EF6999-2E67-9893-50BA-03CB0CF759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A19FC4-7328-FEEF-6574-DF0F14BEC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7E47595-CCBB-E455-195E-DC01F0FB0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E293A0-A266-E7CD-4C8B-EFFB2BDEB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6786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F6BA41-1B9D-BCC6-9FDE-870AA01243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2B32B7-2450-BCA7-7448-34F432824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B3730F-03BA-A5D6-80A7-AAF4D3900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72BB27A-DCA6-C1BC-C4ED-CAD2E0F77F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14543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D2DF35E-1E8D-12E2-80BF-5DE667708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07F820-ACA4-AC20-CD93-D5127DC19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B451F2-5DA2-B6B6-E97D-6408531DD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22926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058A0C-17B7-6695-CBBD-2E89A042BC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185133-427E-24DC-F1F5-BBA5C2C189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B37D36-5AA1-378A-99C6-18B1060E1E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22F454-7255-7D97-F1E1-D21834B82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50D328-5DFE-0217-FB28-19C78D388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68D29F-344D-E7AA-B90E-A6FFBB40A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23583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D00EE7-7872-A3E4-6150-EB5CA9F90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1976B2-BCDC-F32B-F89B-951066C8F6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80FB51-2145-E34E-0523-1E1D86DDD1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537B1B-F0B3-9E0B-B02D-FC8B039E7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E08A8C-C979-74DC-2757-7B6AB8986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68C468-18F8-1662-4608-C02BC77A7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8610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EE4773-BEDA-C3E7-81AA-DA91421DD9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277E85-7711-87C2-D16B-1F7CD25EC0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BFB255-84A0-29DE-F18C-BC63572B2B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50052B-FB2F-42F3-9AC1-2631EAF0176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E32861-9C38-1069-2836-37B23CD0ED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3554E8-9BE0-7338-9D47-EC42D03D5C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B9F26C-BC5B-4CB9-9930-5E80F1DE8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97136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a tower&#10;&#10;Description automatically generated">
            <a:extLst>
              <a:ext uri="{FF2B5EF4-FFF2-40B4-BE49-F238E27FC236}">
                <a16:creationId xmlns:a16="http://schemas.microsoft.com/office/drawing/2014/main" id="{D5842E75-91CA-3B12-91ED-8305A3FB31A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" b="41778"/>
          <a:stretch/>
        </p:blipFill>
        <p:spPr>
          <a:xfrm>
            <a:off x="500543" y="189277"/>
            <a:ext cx="11190914" cy="629488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E7382D2-F536-9F60-7803-2B1940F62061}"/>
              </a:ext>
            </a:extLst>
          </p:cNvPr>
          <p:cNvSpPr txBox="1"/>
          <p:nvPr/>
        </p:nvSpPr>
        <p:spPr>
          <a:xfrm>
            <a:off x="466987" y="6484166"/>
            <a:ext cx="1125802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1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 Mauve alignment generated from aligning the 10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uchnera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hidicola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omes considered in this study along with 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. coli 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ain K12.</a:t>
            </a:r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2296505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ger, Francois, Dr [nfvburger@sun.ac.za]</dc:creator>
  <cp:lastModifiedBy>Oberholster, A, Prof [ambo@sun.ac.za]</cp:lastModifiedBy>
  <cp:revision>3</cp:revision>
  <dcterms:created xsi:type="dcterms:W3CDTF">2024-01-15T09:53:17Z</dcterms:created>
  <dcterms:modified xsi:type="dcterms:W3CDTF">2024-01-17T12:30:54Z</dcterms:modified>
</cp:coreProperties>
</file>